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B69EF4-ABEB-0D46-98D2-94E7A8933A30}" v="8" dt="2022-09-12T08:12:08.14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83"/>
    <p:restoredTop sz="96197"/>
  </p:normalViewPr>
  <p:slideViewPr>
    <p:cSldViewPr snapToGrid="0" snapToObjects="1">
      <p:cViewPr>
        <p:scale>
          <a:sx n="130" d="100"/>
          <a:sy n="130" d="100"/>
        </p:scale>
        <p:origin x="189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dachi Hiroaki" userId="c399da78-718a-421c-91d4-5860850c1366" providerId="ADAL" clId="{2106191A-C561-AD4A-AC8A-DD3C9C89C2DF}"/>
    <pc:docChg chg="modSld">
      <pc:chgData name="Adachi Hiroaki" userId="c399da78-718a-421c-91d4-5860850c1366" providerId="ADAL" clId="{2106191A-C561-AD4A-AC8A-DD3C9C89C2DF}" dt="2022-09-12T05:26:34.929" v="11" actId="20577"/>
      <pc:docMkLst>
        <pc:docMk/>
      </pc:docMkLst>
      <pc:sldChg chg="modSp mod">
        <pc:chgData name="Adachi Hiroaki" userId="c399da78-718a-421c-91d4-5860850c1366" providerId="ADAL" clId="{2106191A-C561-AD4A-AC8A-DD3C9C89C2DF}" dt="2022-09-12T05:26:26.481" v="5" actId="20577"/>
        <pc:sldMkLst>
          <pc:docMk/>
          <pc:sldMk cId="1106958044" sldId="256"/>
        </pc:sldMkLst>
        <pc:spChg chg="mod">
          <ac:chgData name="Adachi Hiroaki" userId="c399da78-718a-421c-91d4-5860850c1366" providerId="ADAL" clId="{2106191A-C561-AD4A-AC8A-DD3C9C89C2DF}" dt="2022-09-12T05:26:26.481" v="5" actId="20577"/>
          <ac:spMkLst>
            <pc:docMk/>
            <pc:sldMk cId="1106958044" sldId="256"/>
            <ac:spMk id="42" creationId="{EA1D7486-26F7-7149-88C9-58F1A941F08D}"/>
          </ac:spMkLst>
        </pc:spChg>
      </pc:sldChg>
      <pc:sldChg chg="modSp mod">
        <pc:chgData name="Adachi Hiroaki" userId="c399da78-718a-421c-91d4-5860850c1366" providerId="ADAL" clId="{2106191A-C561-AD4A-AC8A-DD3C9C89C2DF}" dt="2022-09-12T05:26:34.929" v="11" actId="20577"/>
        <pc:sldMkLst>
          <pc:docMk/>
          <pc:sldMk cId="3273698701" sldId="257"/>
        </pc:sldMkLst>
        <pc:spChg chg="mod">
          <ac:chgData name="Adachi Hiroaki" userId="c399da78-718a-421c-91d4-5860850c1366" providerId="ADAL" clId="{2106191A-C561-AD4A-AC8A-DD3C9C89C2DF}" dt="2022-09-12T05:26:34.929" v="11" actId="20577"/>
          <ac:spMkLst>
            <pc:docMk/>
            <pc:sldMk cId="3273698701" sldId="257"/>
            <ac:spMk id="42" creationId="{EA1D7486-26F7-7149-88C9-58F1A941F08D}"/>
          </ac:spMkLst>
        </pc:spChg>
      </pc:sldChg>
    </pc:docChg>
  </pc:docChgLst>
  <pc:docChgLst>
    <pc:chgData name=" " userId="c399da78-718a-421c-91d4-5860850c1366" providerId="ADAL" clId="{10B69EF4-ABEB-0D46-98D2-94E7A8933A30}"/>
    <pc:docChg chg="undo custSel modSld">
      <pc:chgData name=" " userId="c399da78-718a-421c-91d4-5860850c1366" providerId="ADAL" clId="{10B69EF4-ABEB-0D46-98D2-94E7A8933A30}" dt="2022-09-12T08:14:31.530" v="210" actId="20577"/>
      <pc:docMkLst>
        <pc:docMk/>
      </pc:docMkLst>
      <pc:sldChg chg="addSp modSp mod">
        <pc:chgData name=" " userId="c399da78-718a-421c-91d4-5860850c1366" providerId="ADAL" clId="{10B69EF4-ABEB-0D46-98D2-94E7A8933A30}" dt="2022-09-12T08:14:31.530" v="210" actId="20577"/>
        <pc:sldMkLst>
          <pc:docMk/>
          <pc:sldMk cId="3273698701" sldId="257"/>
        </pc:sldMkLst>
        <pc:spChg chg="add mod">
          <ac:chgData name=" " userId="c399da78-718a-421c-91d4-5860850c1366" providerId="ADAL" clId="{10B69EF4-ABEB-0D46-98D2-94E7A8933A30}" dt="2022-09-12T08:06:44.800" v="67" actId="1035"/>
          <ac:spMkLst>
            <pc:docMk/>
            <pc:sldMk cId="3273698701" sldId="257"/>
            <ac:spMk id="17" creationId="{D2BCEC87-1C42-0148-AD2F-B965E654B498}"/>
          </ac:spMkLst>
        </pc:spChg>
        <pc:spChg chg="add mod">
          <ac:chgData name=" " userId="c399da78-718a-421c-91d4-5860850c1366" providerId="ADAL" clId="{10B69EF4-ABEB-0D46-98D2-94E7A8933A30}" dt="2022-09-12T08:12:11.781" v="112" actId="1035"/>
          <ac:spMkLst>
            <pc:docMk/>
            <pc:sldMk cId="3273698701" sldId="257"/>
            <ac:spMk id="18" creationId="{7E62BF33-75A1-8A4C-8362-9098D0BD8503}"/>
          </ac:spMkLst>
        </pc:spChg>
        <pc:spChg chg="mod">
          <ac:chgData name=" " userId="c399da78-718a-421c-91d4-5860850c1366" providerId="ADAL" clId="{10B69EF4-ABEB-0D46-98D2-94E7A8933A30}" dt="2022-09-12T08:14:31.530" v="210" actId="20577"/>
          <ac:spMkLst>
            <pc:docMk/>
            <pc:sldMk cId="3273698701" sldId="257"/>
            <ac:spMk id="24" creationId="{58D77958-6BF0-2C4C-A776-D95667DFF8A5}"/>
          </ac:spMkLst>
        </pc:spChg>
        <pc:spChg chg="mod">
          <ac:chgData name=" " userId="c399da78-718a-421c-91d4-5860850c1366" providerId="ADAL" clId="{10B69EF4-ABEB-0D46-98D2-94E7A8933A30}" dt="2022-09-12T08:12:31.228" v="136" actId="20577"/>
          <ac:spMkLst>
            <pc:docMk/>
            <pc:sldMk cId="3273698701" sldId="257"/>
            <ac:spMk id="54" creationId="{F3A84349-F144-F445-88B3-7050FCE92CE6}"/>
          </ac:spMkLst>
        </pc:spChg>
        <pc:spChg chg="mod">
          <ac:chgData name=" " userId="c399da78-718a-421c-91d4-5860850c1366" providerId="ADAL" clId="{10B69EF4-ABEB-0D46-98D2-94E7A8933A30}" dt="2022-09-12T08:12:40.701" v="137" actId="207"/>
          <ac:spMkLst>
            <pc:docMk/>
            <pc:sldMk cId="3273698701" sldId="257"/>
            <ac:spMk id="68" creationId="{60F2F024-F9CC-194F-A7B3-E35D0704CBE7}"/>
          </ac:spMkLst>
        </pc:spChg>
        <pc:cxnChg chg="mod">
          <ac:chgData name=" " userId="c399da78-718a-421c-91d4-5860850c1366" providerId="ADAL" clId="{10B69EF4-ABEB-0D46-98D2-94E7A8933A30}" dt="2022-09-12T08:11:44.889" v="107" actId="1036"/>
          <ac:cxnSpMkLst>
            <pc:docMk/>
            <pc:sldMk cId="3273698701" sldId="257"/>
            <ac:cxnSpMk id="52" creationId="{BA753104-4C82-B949-850A-96F48C6983B5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0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7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04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47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0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47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371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17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0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2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23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91">
            <a:extLst>
              <a:ext uri="{FF2B5EF4-FFF2-40B4-BE49-F238E27FC236}">
                <a16:creationId xmlns:a16="http://schemas.microsoft.com/office/drawing/2014/main" id="{59F53D44-D1FD-8743-8D6B-779A4C7B294B}"/>
              </a:ext>
            </a:extLst>
          </p:cNvPr>
          <p:cNvSpPr/>
          <p:nvPr/>
        </p:nvSpPr>
        <p:spPr>
          <a:xfrm>
            <a:off x="51175" y="8794999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43C93ADA-611B-5B4F-9FB5-12281BAA8330}"/>
              </a:ext>
            </a:extLst>
          </p:cNvPr>
          <p:cNvSpPr/>
          <p:nvPr/>
        </p:nvSpPr>
        <p:spPr>
          <a:xfrm>
            <a:off x="58004" y="6991581"/>
            <a:ext cx="6754598" cy="31130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BC742CA-7806-BE4B-8E16-85CE9F9794C1}"/>
              </a:ext>
            </a:extLst>
          </p:cNvPr>
          <p:cNvSpPr/>
          <p:nvPr/>
        </p:nvSpPr>
        <p:spPr>
          <a:xfrm>
            <a:off x="58004" y="6390261"/>
            <a:ext cx="6754598" cy="31130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B8CE5847-2B23-624C-B898-25996AC3B901}"/>
              </a:ext>
            </a:extLst>
          </p:cNvPr>
          <p:cNvSpPr/>
          <p:nvPr/>
        </p:nvSpPr>
        <p:spPr>
          <a:xfrm>
            <a:off x="58004" y="820181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EFC13851-8D6E-3F4A-A9DF-622597C261F7}"/>
              </a:ext>
            </a:extLst>
          </p:cNvPr>
          <p:cNvSpPr/>
          <p:nvPr/>
        </p:nvSpPr>
        <p:spPr>
          <a:xfrm>
            <a:off x="58004" y="759424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148961D-17EC-4F4A-931C-E5D2B35273A2}"/>
              </a:ext>
            </a:extLst>
          </p:cNvPr>
          <p:cNvSpPr/>
          <p:nvPr/>
        </p:nvSpPr>
        <p:spPr>
          <a:xfrm>
            <a:off x="58004" y="577384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5155559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C1A59B4C-F936-D44E-B90B-E6458E8DFB5E}"/>
              </a:ext>
            </a:extLst>
          </p:cNvPr>
          <p:cNvSpPr/>
          <p:nvPr/>
        </p:nvSpPr>
        <p:spPr>
          <a:xfrm>
            <a:off x="58004" y="4407661"/>
            <a:ext cx="6754598" cy="468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9AF246CF-9BB9-214B-9AD0-CA20C5A5C8CC}"/>
              </a:ext>
            </a:extLst>
          </p:cNvPr>
          <p:cNvSpPr/>
          <p:nvPr/>
        </p:nvSpPr>
        <p:spPr>
          <a:xfrm>
            <a:off x="58004" y="380204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189094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8EEEA8ED-DF50-F142-844E-AB93237D27FC}"/>
              </a:ext>
            </a:extLst>
          </p:cNvPr>
          <p:cNvSpPr/>
          <p:nvPr/>
        </p:nvSpPr>
        <p:spPr>
          <a:xfrm>
            <a:off x="58004" y="2576182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F184773-05EA-404C-9A6D-15233C400BA8}"/>
              </a:ext>
            </a:extLst>
          </p:cNvPr>
          <p:cNvSpPr/>
          <p:nvPr/>
        </p:nvSpPr>
        <p:spPr>
          <a:xfrm>
            <a:off x="58004" y="196327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24513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2 Table. </a:t>
            </a:r>
            <a:r>
              <a:rPr lang="en-US" altLang="ja-JP" sz="1050" dirty="0">
                <a:latin typeface="Arial"/>
                <a:cs typeface="Arial"/>
              </a:rPr>
              <a:t>Primers Used in this study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82344" y="711644"/>
            <a:ext cx="5533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5" name="テキスト ボックス 18">
            <a:extLst>
              <a:ext uri="{FF2B5EF4-FFF2-40B4-BE49-F238E27FC236}">
                <a16:creationId xmlns:a16="http://schemas.microsoft.com/office/drawing/2014/main" id="{2AEE24A3-BC69-9A4B-93BF-8B9B4B04E905}"/>
              </a:ext>
            </a:extLst>
          </p:cNvPr>
          <p:cNvSpPr txBox="1"/>
          <p:nvPr/>
        </p:nvSpPr>
        <p:spPr>
          <a:xfrm>
            <a:off x="1816427" y="711644"/>
            <a:ext cx="12506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equence (5’&gt;3’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195590" y="716807"/>
            <a:ext cx="1417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Usage in this stud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9405787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87855" y="1003487"/>
            <a:ext cx="1710725" cy="8402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ested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PCR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ested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PCR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pi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pi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without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stop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2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1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2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1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3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3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NbPrf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TRV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NbPrf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TRV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3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2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bEF-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α RT </a:t>
            </a:r>
            <a:r>
              <a:rPr lang="en-US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bEF-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α RT </a:t>
            </a:r>
            <a:r>
              <a:rPr lang="en-US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2a/b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2a/b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3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3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NRC4 RT </a:t>
            </a:r>
            <a:r>
              <a:rPr lang="en-US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NRC4 RT </a:t>
            </a:r>
            <a:r>
              <a:rPr lang="en-US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テキスト ボックス 24">
            <a:extLst>
              <a:ext uri="{FF2B5EF4-FFF2-40B4-BE49-F238E27FC236}">
                <a16:creationId xmlns:a16="http://schemas.microsoft.com/office/drawing/2014/main" id="{60F2F024-F9CC-194F-A7B3-E35D0704CBE7}"/>
              </a:ext>
            </a:extLst>
          </p:cNvPr>
          <p:cNvSpPr txBox="1"/>
          <p:nvPr/>
        </p:nvSpPr>
        <p:spPr>
          <a:xfrm>
            <a:off x="1816427" y="1003487"/>
            <a:ext cx="3379163" cy="8402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AGAGTCTTGGTGAAATAATG</a:t>
            </a:r>
          </a:p>
          <a:p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TCTCTCTTCGTGGAATGG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TGT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AAGAC</a:t>
            </a:r>
            <a:r>
              <a:rPr lang="en-US" altLang="ja-JP" sz="1000" dirty="0">
                <a:latin typeface="Arial"/>
                <a:cs typeface="Arial"/>
              </a:rPr>
              <a:t>AAAATGGCGGATACAGCAGTGGA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latin typeface="Arial"/>
                <a:cs typeface="Arial"/>
              </a:rPr>
              <a:t>TGT</a:t>
            </a:r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AAGAC</a:t>
            </a:r>
            <a:r>
              <a:rPr lang="en-US" altLang="ja-JP" sz="1000" dirty="0" err="1">
                <a:latin typeface="Arial"/>
                <a:cs typeface="Arial"/>
              </a:rPr>
              <a:t>AACGAAccGAGATCGGGAGGGAAGATGG</a:t>
            </a:r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CCA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AGGAGCGAACGTTGCGGTGGAG </a:t>
            </a: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CCA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ATCGTCACAAATCTGCCAACCCCTTTG</a:t>
            </a:r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GGAGATGGCAGATGTAGCAGCAGAT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GTACTGAGCAAATTTATTTTTAT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GGAGATGGCAGATGCAGTAGT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GTTTATTTTTCTCTTTGTGCA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GGAGATGGCGGATACAGCAGTGGAC</a:t>
            </a:r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GTTCCGGTAGGGGAACCTTTCT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GGAGATGGCCGAGGAGTGTCGCG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GTCATTTTAATGGTAAGGTTGAAA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CGGTAGGGGAACCTTTCT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CGGAATGGCAGATGTAGCAGCA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CCATTTATTTTTCTCTTTGTGCA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ATGGCGGATACAGCAGTGGA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CCATCACAAATCTGCCAACCCCTTTG</a:t>
            </a:r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GGTCCAGTATGCCTGGGTGCTTGA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GAATTCACAGGGACAGTTCCAATACCA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GTGGATGAGAGTGTGGGTG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GCAGGGATCTCAAAGCCT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CCTCGAAAAGCTGAAGTTG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TGTCCCCTAAACGCATTTT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ACAAATCTGCGGGTTGA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GGATGGCATTGAAGTCACCT</a:t>
            </a:r>
          </a:p>
        </p:txBody>
      </p:sp>
      <p:sp>
        <p:nvSpPr>
          <p:cNvPr id="93" name="テキスト ボックス 23">
            <a:extLst>
              <a:ext uri="{FF2B5EF4-FFF2-40B4-BE49-F238E27FC236}">
                <a16:creationId xmlns:a16="http://schemas.microsoft.com/office/drawing/2014/main" id="{89706E7E-A53D-7E4D-A73F-128C61557D6D}"/>
              </a:ext>
            </a:extLst>
          </p:cNvPr>
          <p:cNvSpPr txBox="1"/>
          <p:nvPr/>
        </p:nvSpPr>
        <p:spPr>
          <a:xfrm>
            <a:off x="5143340" y="998759"/>
            <a:ext cx="1809004" cy="855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cloning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cloning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cloning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cloning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, TRV:NRC2/3/X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3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3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4, TRV:NRC4/X</a:t>
            </a: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TRV:NRC2/3/4/X</a:t>
            </a: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4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X, TRV:NRC2/3/X,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NAi:NRCX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X, TRV:NRC4/X, TRV:NRC2/3/4/X,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NAi:NRCX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TRV:Prf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TRV:Prf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/3/X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/3/X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4/X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4/X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/3/4/X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</p:txBody>
      </p:sp>
    </p:spTree>
    <p:extLst>
      <p:ext uri="{BB962C8B-B14F-4D97-AF65-F5344CB8AC3E}">
        <p14:creationId xmlns:p14="http://schemas.microsoft.com/office/powerpoint/2010/main" val="1106958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85">
            <a:extLst>
              <a:ext uri="{FF2B5EF4-FFF2-40B4-BE49-F238E27FC236}">
                <a16:creationId xmlns:a16="http://schemas.microsoft.com/office/drawing/2014/main" id="{7E62BF33-75A1-8A4C-8362-9098D0BD8503}"/>
              </a:ext>
            </a:extLst>
          </p:cNvPr>
          <p:cNvSpPr/>
          <p:nvPr/>
        </p:nvSpPr>
        <p:spPr>
          <a:xfrm>
            <a:off x="58004" y="5471914"/>
            <a:ext cx="6754598" cy="468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85">
            <a:extLst>
              <a:ext uri="{FF2B5EF4-FFF2-40B4-BE49-F238E27FC236}">
                <a16:creationId xmlns:a16="http://schemas.microsoft.com/office/drawing/2014/main" id="{D2BCEC87-1C42-0148-AD2F-B965E654B498}"/>
              </a:ext>
            </a:extLst>
          </p:cNvPr>
          <p:cNvSpPr/>
          <p:nvPr/>
        </p:nvSpPr>
        <p:spPr>
          <a:xfrm>
            <a:off x="58004" y="4544711"/>
            <a:ext cx="6754598" cy="468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D442A61-EC1D-5246-8754-5DF019B34A27}"/>
              </a:ext>
            </a:extLst>
          </p:cNvPr>
          <p:cNvSpPr/>
          <p:nvPr/>
        </p:nvSpPr>
        <p:spPr>
          <a:xfrm>
            <a:off x="52358" y="2725449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3CDADE6-08D3-4A4F-A29C-3788EFBB1B3C}"/>
              </a:ext>
            </a:extLst>
          </p:cNvPr>
          <p:cNvSpPr/>
          <p:nvPr/>
        </p:nvSpPr>
        <p:spPr>
          <a:xfrm>
            <a:off x="50100" y="210605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3935935"/>
            <a:ext cx="6754598" cy="32112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340016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15023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2 Table. </a:t>
            </a:r>
            <a:r>
              <a:rPr lang="en-US" altLang="ja-JP" sz="1050" dirty="0">
                <a:latin typeface="Arial"/>
                <a:cs typeface="Arial"/>
              </a:rPr>
              <a:t>Continued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82344" y="711644"/>
            <a:ext cx="5533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5" name="テキスト ボックス 18">
            <a:extLst>
              <a:ext uri="{FF2B5EF4-FFF2-40B4-BE49-F238E27FC236}">
                <a16:creationId xmlns:a16="http://schemas.microsoft.com/office/drawing/2014/main" id="{2AEE24A3-BC69-9A4B-93BF-8B9B4B04E905}"/>
              </a:ext>
            </a:extLst>
          </p:cNvPr>
          <p:cNvSpPr txBox="1"/>
          <p:nvPr/>
        </p:nvSpPr>
        <p:spPr>
          <a:xfrm>
            <a:off x="1816427" y="711644"/>
            <a:ext cx="12506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equence (5’&gt;3’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195590" y="716807"/>
            <a:ext cx="1417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Usage in this stud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5999996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87855" y="1003487"/>
            <a:ext cx="1494107" cy="4862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D475V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H474R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H474R D475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random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over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17aa NRC2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17aa ZAR1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テキスト ボックス 24">
            <a:extLst>
              <a:ext uri="{FF2B5EF4-FFF2-40B4-BE49-F238E27FC236}">
                <a16:creationId xmlns:a16="http://schemas.microsoft.com/office/drawing/2014/main" id="{60F2F024-F9CC-194F-A7B3-E35D0704CBE7}"/>
              </a:ext>
            </a:extLst>
          </p:cNvPr>
          <p:cNvSpPr txBox="1"/>
          <p:nvPr/>
        </p:nvSpPr>
        <p:spPr>
          <a:xfrm>
            <a:off x="1816427" y="1003487"/>
            <a:ext cx="3379163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/>
                <a:cs typeface="Arial"/>
              </a:rPr>
              <a:t>CCAAGTGCATCAATCTGTG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TGGCCTTTGTTCTGGAAT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GGATACAGCAGTGGACTTTGTGATAGATAACCTGAAGCAGCTATTAACGGACAATGTTAAATTAATA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CGAACCCTGTGTGGCCTTGGATCCA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 err="1">
                <a:latin typeface="Arial"/>
                <a:cs typeface="Arial"/>
              </a:rPr>
              <a:t>AAAACGTGTCGCGTACATGtTATGTTACACGAGTT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 err="1">
                <a:latin typeface="Arial"/>
                <a:cs typeface="Arial"/>
              </a:rPr>
              <a:t>AAAACGTGTCGCGTAagaGATATGTTACACGAGTT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 err="1">
                <a:latin typeface="Arial"/>
                <a:cs typeface="Arial"/>
              </a:rPr>
              <a:t>AAAACGTGTCGCGTAagaGtTATGTTACACGAGTTC</a:t>
            </a:r>
            <a:endParaRPr lang="en-US" altLang="ja-JP" sz="1000" dirty="0">
              <a:latin typeface="Arial"/>
              <a:cs typeface="Arial"/>
            </a:endParaRP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 err="1">
                <a:latin typeface="Arial"/>
                <a:cs typeface="Arial"/>
              </a:rPr>
              <a:t>AAAACGTGTCGCGTAnnnnnnATGTTACACGAGTTC</a:t>
            </a:r>
            <a:endParaRPr lang="en-US" altLang="ja-JP" sz="1000" dirty="0">
              <a:latin typeface="Arial"/>
              <a:cs typeface="Arial"/>
            </a:endParaRP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TACGCGACACGTTTT</a:t>
            </a: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AT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GGATACAGCAGTGGAC</a:t>
            </a: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 err="1">
                <a:latin typeface="Arial"/>
                <a:cs typeface="Arial"/>
              </a:rPr>
              <a:t>AAT</a:t>
            </a:r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CGAAccGAGATCGGGAGGGAAGATGG</a:t>
            </a:r>
            <a:endParaRPr lang="en-US" altLang="ja-JP" sz="1000" dirty="0">
              <a:latin typeface="Arial"/>
              <a:cs typeface="Arial"/>
            </a:endParaRP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AATGTGGCTGTTGAGTTCCTGGTTCAAAATCTCATGCAATTGCTACGTGATAACACATATCTAATTG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TTGCTGCGTGATAACACATATCTAATTG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TGGACGCTGTTGTAACAGTGTTTTTAGAGAAAACCTTGAACATCCTCCGTGATAACACATATCTAATTG 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8D77958-6BF0-2C4C-A776-D95667DFF8A5}"/>
              </a:ext>
            </a:extLst>
          </p:cNvPr>
          <p:cNvSpPr txBox="1"/>
          <p:nvPr/>
        </p:nvSpPr>
        <p:spPr>
          <a:xfrm>
            <a:off x="5208653" y="998759"/>
            <a:ext cx="1591343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, MADA chimera</a:t>
            </a: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ADA chimera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ADA chimera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ADA chimera</a:t>
            </a:r>
          </a:p>
        </p:txBody>
      </p:sp>
    </p:spTree>
    <p:extLst>
      <p:ext uri="{BB962C8B-B14F-4D97-AF65-F5344CB8AC3E}">
        <p14:creationId xmlns:p14="http://schemas.microsoft.com/office/powerpoint/2010/main" val="3273698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0</TotalTime>
  <Words>392</Words>
  <Application>Microsoft Macintosh PowerPoint</Application>
  <PresentationFormat>A4 210 x 297 mm</PresentationFormat>
  <Paragraphs>24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aki Adachi (TSL)</dc:creator>
  <cp:lastModifiedBy>Hiroaki Adachi (TSL)</cp:lastModifiedBy>
  <cp:revision>49</cp:revision>
  <dcterms:created xsi:type="dcterms:W3CDTF">2019-04-29T00:03:08Z</dcterms:created>
  <dcterms:modified xsi:type="dcterms:W3CDTF">2022-09-12T08:14:38Z</dcterms:modified>
</cp:coreProperties>
</file>